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20458113" cy="18302288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1"/>
          <p:cNvSpPr>
            <a:spLocks noGrp="1"/>
          </p:cNvSpPr>
          <p:nvPr>
            <p:ph type="sldImg"/>
          </p:nvPr>
        </p:nvSpPr>
        <p:spPr>
          <a:xfrm>
            <a:off x="1538280" y="812880"/>
            <a:ext cx="4479840" cy="400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 type="dt" idx="1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 type="ftr" idx="2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6"/>
          <p:cNvSpPr>
            <a:spLocks noGrp="1"/>
          </p:cNvSpPr>
          <p:nvPr>
            <p:ph type="sldNum" idx="3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C079BF29-4F34-49AD-976E-9FEC586EECD2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527B6DA7-6F2D-4109-920A-1A96992A9A13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Microsoft YaHe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D8EBD15A-4092-4362-9D68-984CD9AF9133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Microsoft YaHe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538280" y="812880"/>
            <a:ext cx="4481640" cy="400824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61B5E7B4-A32A-433E-8A80-B583B4F796E5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Microsoft YaHe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1841256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1022760" y="9826920"/>
            <a:ext cx="1841256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1045764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1022760" y="982692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/>
          </p:nvPr>
        </p:nvSpPr>
        <p:spPr>
          <a:xfrm>
            <a:off x="10457640" y="982692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247880" y="428256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473360" y="428256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022760" y="982692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/>
          </p:nvPr>
        </p:nvSpPr>
        <p:spPr>
          <a:xfrm>
            <a:off x="7247880" y="982692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/>
          </p:nvPr>
        </p:nvSpPr>
        <p:spPr>
          <a:xfrm>
            <a:off x="13473360" y="9826920"/>
            <a:ext cx="592848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1022760" y="4282560"/>
            <a:ext cx="1841256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1841256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898524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/>
          </p:nvPr>
        </p:nvSpPr>
        <p:spPr>
          <a:xfrm>
            <a:off x="10457640" y="4282560"/>
            <a:ext cx="898524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1022760" y="730080"/>
            <a:ext cx="18412560" cy="14167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0457640" y="4282560"/>
            <a:ext cx="898524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/>
          </p:nvPr>
        </p:nvSpPr>
        <p:spPr>
          <a:xfrm>
            <a:off x="1022760" y="982692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8985240" cy="1061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1045764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10457640" y="982692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022760" y="730080"/>
            <a:ext cx="18412560" cy="305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102276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10457640" y="4282560"/>
            <a:ext cx="898524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1022760" y="9826920"/>
            <a:ext cx="18412560" cy="506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CasellaDiTesto 1"/>
          <p:cNvSpPr/>
          <p:nvPr/>
        </p:nvSpPr>
        <p:spPr>
          <a:xfrm>
            <a:off x="365040" y="133200"/>
            <a:ext cx="1998036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914400" indent="-914400" algn="ctr">
              <a:lnSpc>
                <a:spcPct val="100000"/>
              </a:lnSpc>
              <a:buClr>
                <a:srgbClr val="000000"/>
              </a:buClr>
              <a:buFont typeface="Arial"/>
              <a:buAutoNum type="alphaUcPeriod"/>
              <a:tabLst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RAxML tree with no constraint: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log-likelihood: -33298.13057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deltaL: 6.1047e-06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bp-RELL: 0.245 (+); p-KH: 0.502 (+); p-SH: 0.85 (+); c-ELW: 0.333 (+) ;p-AU: 0.49 (+)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marL="914400" indent="-914400" algn="ctr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4" name="Immagine 4" descr=""/>
          <p:cNvPicPr/>
          <p:nvPr/>
        </p:nvPicPr>
        <p:blipFill>
          <a:blip r:embed="rId1"/>
          <a:srcRect l="9417" t="0" r="0" b="0"/>
          <a:stretch/>
        </p:blipFill>
        <p:spPr>
          <a:xfrm>
            <a:off x="-181080" y="3029040"/>
            <a:ext cx="20564640" cy="11882520"/>
          </a:xfrm>
          <a:prstGeom prst="rect">
            <a:avLst/>
          </a:prstGeom>
          <a:ln w="0"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433" descr=""/>
          <p:cNvPicPr/>
          <p:nvPr/>
        </p:nvPicPr>
        <p:blipFill>
          <a:blip r:embed="rId1"/>
          <a:stretch/>
        </p:blipFill>
        <p:spPr>
          <a:xfrm>
            <a:off x="144360" y="3821040"/>
            <a:ext cx="20297880" cy="11450880"/>
          </a:xfrm>
          <a:prstGeom prst="rect">
            <a:avLst/>
          </a:prstGeom>
          <a:ln w="0">
            <a:noFill/>
          </a:ln>
        </p:spPr>
      </p:pic>
      <p:sp>
        <p:nvSpPr>
          <p:cNvPr id="46" name="CasellaDiTesto 437"/>
          <p:cNvSpPr/>
          <p:nvPr/>
        </p:nvSpPr>
        <p:spPr>
          <a:xfrm>
            <a:off x="303120" y="509760"/>
            <a:ext cx="1998036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B. RAxML tree with </a:t>
            </a:r>
            <a:r>
              <a:rPr b="1" i="1" lang="it-IT" sz="3600" spc="-1" strike="noStrike">
                <a:solidFill>
                  <a:srgbClr val="000000"/>
                </a:solidFill>
                <a:latin typeface="Arial"/>
              </a:rPr>
              <a:t>Gigaspora </a:t>
            </a: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species and bacteria assumed to be monophyletic: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log-likelihood: -33298.13057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deltaL: 0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bp-RELL: 0.421 (+); p-KH: 0.498 (+); p-SH: 1 (+); c-ELW: 0.333 (+) ;p-AU: 0.484 (+)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CasellaDiTesto 1"/>
          <p:cNvSpPr/>
          <p:nvPr/>
        </p:nvSpPr>
        <p:spPr>
          <a:xfrm>
            <a:off x="365040" y="98280"/>
            <a:ext cx="1980252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C. RAxML tree with all fungi assumed to be monophyletic 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log-likelihood: -33340.0398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deltaL: 0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3600" spc="-1" strike="noStrike">
                <a:solidFill>
                  <a:srgbClr val="000000"/>
                </a:solidFill>
                <a:latin typeface="Arial"/>
              </a:rPr>
              <a:t>bp-RELL: 41.909 (-); p-KH: 0.0001 (-); p-SH: 0.0011 (-); c-ELW: 3.3e-05 (-) ; 1.24e-05 (-)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Immagine 3" descr=""/>
          <p:cNvPicPr/>
          <p:nvPr/>
        </p:nvPicPr>
        <p:blipFill>
          <a:blip r:embed="rId1"/>
          <a:stretch/>
        </p:blipFill>
        <p:spPr>
          <a:xfrm>
            <a:off x="291960" y="3724200"/>
            <a:ext cx="20223360" cy="1189188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Francesco Venice</dc:creator>
  <dc:description/>
  <dc:language>en-US</dc:language>
  <cp:lastModifiedBy>Francesco Venice</cp:lastModifiedBy>
  <dcterms:modified xsi:type="dcterms:W3CDTF">2020-10-09T13:14:28Z</dcterms:modified>
  <cp:revision>28</cp:revision>
  <dc:subject/>
  <dc:title>Presentazione standard di PowerPoint</dc:title>
</cp:coreProperties>
</file>